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1975" r:id="rId2"/>
    <p:sldId id="1979" r:id="rId3"/>
    <p:sldId id="1981" r:id="rId4"/>
  </p:sldIdLst>
  <p:sldSz cx="9212263" cy="119459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009900"/>
    <a:srgbClr val="00FFFF"/>
    <a:srgbClr val="CC00CC"/>
    <a:srgbClr val="CC0099"/>
    <a:srgbClr val="0000FF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039" autoAdjust="0"/>
    <p:restoredTop sz="83515" autoAdjust="0"/>
  </p:normalViewPr>
  <p:slideViewPr>
    <p:cSldViewPr snapToGrid="0">
      <p:cViewPr varScale="1">
        <p:scale>
          <a:sx n="81" d="100"/>
          <a:sy n="81" d="100"/>
        </p:scale>
        <p:origin x="2852" y="8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95" d="100"/>
        <a:sy n="9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7" d="100"/>
          <a:sy n="77" d="100"/>
        </p:scale>
        <p:origin x="3420" y="8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D61F2-45A6-5B48-8C50-F880E7C0E86A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143000"/>
            <a:ext cx="23812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A2A388-071B-E047-8648-18EE510B8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4949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 Categorization of immunophenotypic markers used in CODEX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A2A388-071B-E047-8648-18EE510B8F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3302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2. Closest cell-cell distances in MCD and UCD ordered by difference from RLN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A2A388-071B-E047-8648-18EE510B8FD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9846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Table 3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analysis of UCD and MCD. </a:t>
            </a:r>
            <a:r>
              <a:rPr lang="en-US" dirty="0"/>
              <a:t>Copy number variants (CNV) and sequence variants including single nucleotide variants (SNV) and small Insertions (Ins) and Deletions (Del) identified through SNP array and </a:t>
            </a:r>
            <a:r>
              <a:rPr lang="en-US" sz="1800" u="none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rgeted DNA sequencing analyses</a:t>
            </a:r>
            <a:r>
              <a:rPr lang="en-US" dirty="0"/>
              <a:t>. The variant allele fraction for each variant is shown within parenthes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A2A388-071B-E047-8648-18EE510B8FD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6179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0920" y="1955042"/>
            <a:ext cx="7830424" cy="4158956"/>
          </a:xfrm>
        </p:spPr>
        <p:txBody>
          <a:bodyPr anchor="b"/>
          <a:lstStyle>
            <a:lvl1pPr algn="ctr">
              <a:defRPr sz="60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1533" y="6274384"/>
            <a:ext cx="6909197" cy="2884169"/>
          </a:xfrm>
        </p:spPr>
        <p:txBody>
          <a:bodyPr/>
          <a:lstStyle>
            <a:lvl1pPr marL="0" indent="0" algn="ctr">
              <a:buNone/>
              <a:defRPr sz="2418"/>
            </a:lvl1pPr>
            <a:lvl2pPr marL="460629" indent="0" algn="ctr">
              <a:buNone/>
              <a:defRPr sz="2015"/>
            </a:lvl2pPr>
            <a:lvl3pPr marL="921258" indent="0" algn="ctr">
              <a:buNone/>
              <a:defRPr sz="1814"/>
            </a:lvl3pPr>
            <a:lvl4pPr marL="1381887" indent="0" algn="ctr">
              <a:buNone/>
              <a:defRPr sz="1612"/>
            </a:lvl4pPr>
            <a:lvl5pPr marL="1842516" indent="0" algn="ctr">
              <a:buNone/>
              <a:defRPr sz="1612"/>
            </a:lvl5pPr>
            <a:lvl6pPr marL="2303145" indent="0" algn="ctr">
              <a:buNone/>
              <a:defRPr sz="1612"/>
            </a:lvl6pPr>
            <a:lvl7pPr marL="2763774" indent="0" algn="ctr">
              <a:buNone/>
              <a:defRPr sz="1612"/>
            </a:lvl7pPr>
            <a:lvl8pPr marL="3224403" indent="0" algn="ctr">
              <a:buNone/>
              <a:defRPr sz="1612"/>
            </a:lvl8pPr>
            <a:lvl9pPr marL="3685032" indent="0" algn="ctr">
              <a:buNone/>
              <a:defRPr sz="161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65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08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92526" y="636011"/>
            <a:ext cx="1986394" cy="101236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33344" y="636011"/>
            <a:ext cx="5844029" cy="101236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812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505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545" y="2978192"/>
            <a:ext cx="7945577" cy="4969178"/>
          </a:xfrm>
        </p:spPr>
        <p:txBody>
          <a:bodyPr anchor="b"/>
          <a:lstStyle>
            <a:lvl1pPr>
              <a:defRPr sz="60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545" y="7994380"/>
            <a:ext cx="7945577" cy="2613173"/>
          </a:xfrm>
        </p:spPr>
        <p:txBody>
          <a:bodyPr/>
          <a:lstStyle>
            <a:lvl1pPr marL="0" indent="0">
              <a:buNone/>
              <a:defRPr sz="2418">
                <a:solidFill>
                  <a:schemeClr val="tx1"/>
                </a:solidFill>
              </a:defRPr>
            </a:lvl1pPr>
            <a:lvl2pPr marL="460629" indent="0">
              <a:buNone/>
              <a:defRPr sz="2015">
                <a:solidFill>
                  <a:schemeClr val="tx1">
                    <a:tint val="75000"/>
                  </a:schemeClr>
                </a:solidFill>
              </a:defRPr>
            </a:lvl2pPr>
            <a:lvl3pPr marL="921258" indent="0">
              <a:buNone/>
              <a:defRPr sz="1814">
                <a:solidFill>
                  <a:schemeClr val="tx1">
                    <a:tint val="75000"/>
                  </a:schemeClr>
                </a:solidFill>
              </a:defRPr>
            </a:lvl3pPr>
            <a:lvl4pPr marL="1381887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4pPr>
            <a:lvl5pPr marL="1842516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5pPr>
            <a:lvl6pPr marL="2303145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6pPr>
            <a:lvl7pPr marL="2763774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7pPr>
            <a:lvl8pPr marL="3224403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8pPr>
            <a:lvl9pPr marL="3685032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344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3343" y="3180053"/>
            <a:ext cx="3915212" cy="7579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708" y="3180053"/>
            <a:ext cx="3915212" cy="7579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955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4543" y="636013"/>
            <a:ext cx="7945577" cy="230899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4544" y="2928415"/>
            <a:ext cx="3897218" cy="1435171"/>
          </a:xfrm>
        </p:spPr>
        <p:txBody>
          <a:bodyPr anchor="b"/>
          <a:lstStyle>
            <a:lvl1pPr marL="0" indent="0">
              <a:buNone/>
              <a:defRPr sz="2418" b="1"/>
            </a:lvl1pPr>
            <a:lvl2pPr marL="460629" indent="0">
              <a:buNone/>
              <a:defRPr sz="2015" b="1"/>
            </a:lvl2pPr>
            <a:lvl3pPr marL="921258" indent="0">
              <a:buNone/>
              <a:defRPr sz="1814" b="1"/>
            </a:lvl3pPr>
            <a:lvl4pPr marL="1381887" indent="0">
              <a:buNone/>
              <a:defRPr sz="1612" b="1"/>
            </a:lvl4pPr>
            <a:lvl5pPr marL="1842516" indent="0">
              <a:buNone/>
              <a:defRPr sz="1612" b="1"/>
            </a:lvl5pPr>
            <a:lvl6pPr marL="2303145" indent="0">
              <a:buNone/>
              <a:defRPr sz="1612" b="1"/>
            </a:lvl6pPr>
            <a:lvl7pPr marL="2763774" indent="0">
              <a:buNone/>
              <a:defRPr sz="1612" b="1"/>
            </a:lvl7pPr>
            <a:lvl8pPr marL="3224403" indent="0">
              <a:buNone/>
              <a:defRPr sz="1612" b="1"/>
            </a:lvl8pPr>
            <a:lvl9pPr marL="3685032" indent="0">
              <a:buNone/>
              <a:defRPr sz="16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4544" y="4363586"/>
            <a:ext cx="3897218" cy="64181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708" y="2928415"/>
            <a:ext cx="3916412" cy="1435171"/>
          </a:xfrm>
        </p:spPr>
        <p:txBody>
          <a:bodyPr anchor="b"/>
          <a:lstStyle>
            <a:lvl1pPr marL="0" indent="0">
              <a:buNone/>
              <a:defRPr sz="2418" b="1"/>
            </a:lvl1pPr>
            <a:lvl2pPr marL="460629" indent="0">
              <a:buNone/>
              <a:defRPr sz="2015" b="1"/>
            </a:lvl2pPr>
            <a:lvl3pPr marL="921258" indent="0">
              <a:buNone/>
              <a:defRPr sz="1814" b="1"/>
            </a:lvl3pPr>
            <a:lvl4pPr marL="1381887" indent="0">
              <a:buNone/>
              <a:defRPr sz="1612" b="1"/>
            </a:lvl4pPr>
            <a:lvl5pPr marL="1842516" indent="0">
              <a:buNone/>
              <a:defRPr sz="1612" b="1"/>
            </a:lvl5pPr>
            <a:lvl6pPr marL="2303145" indent="0">
              <a:buNone/>
              <a:defRPr sz="1612" b="1"/>
            </a:lvl6pPr>
            <a:lvl7pPr marL="2763774" indent="0">
              <a:buNone/>
              <a:defRPr sz="1612" b="1"/>
            </a:lvl7pPr>
            <a:lvl8pPr marL="3224403" indent="0">
              <a:buNone/>
              <a:defRPr sz="1612" b="1"/>
            </a:lvl8pPr>
            <a:lvl9pPr marL="3685032" indent="0">
              <a:buNone/>
              <a:defRPr sz="16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708" y="4363586"/>
            <a:ext cx="3916412" cy="64181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416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14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89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4543" y="796396"/>
            <a:ext cx="2971195" cy="2787386"/>
          </a:xfrm>
        </p:spPr>
        <p:txBody>
          <a:bodyPr anchor="b"/>
          <a:lstStyle>
            <a:lvl1pPr>
              <a:defRPr sz="32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16412" y="1719996"/>
            <a:ext cx="4663708" cy="8489359"/>
          </a:xfrm>
        </p:spPr>
        <p:txBody>
          <a:bodyPr/>
          <a:lstStyle>
            <a:lvl1pPr>
              <a:defRPr sz="3224"/>
            </a:lvl1pPr>
            <a:lvl2pPr>
              <a:defRPr sz="2821"/>
            </a:lvl2pPr>
            <a:lvl3pPr>
              <a:defRPr sz="2418"/>
            </a:lvl3pPr>
            <a:lvl4pPr>
              <a:defRPr sz="2015"/>
            </a:lvl4pPr>
            <a:lvl5pPr>
              <a:defRPr sz="2015"/>
            </a:lvl5pPr>
            <a:lvl6pPr>
              <a:defRPr sz="2015"/>
            </a:lvl6pPr>
            <a:lvl7pPr>
              <a:defRPr sz="2015"/>
            </a:lvl7pPr>
            <a:lvl8pPr>
              <a:defRPr sz="2015"/>
            </a:lvl8pPr>
            <a:lvl9pPr>
              <a:defRPr sz="201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4543" y="3583782"/>
            <a:ext cx="2971195" cy="6639398"/>
          </a:xfrm>
        </p:spPr>
        <p:txBody>
          <a:bodyPr/>
          <a:lstStyle>
            <a:lvl1pPr marL="0" indent="0">
              <a:buNone/>
              <a:defRPr sz="1612"/>
            </a:lvl1pPr>
            <a:lvl2pPr marL="460629" indent="0">
              <a:buNone/>
              <a:defRPr sz="1411"/>
            </a:lvl2pPr>
            <a:lvl3pPr marL="921258" indent="0">
              <a:buNone/>
              <a:defRPr sz="1209"/>
            </a:lvl3pPr>
            <a:lvl4pPr marL="1381887" indent="0">
              <a:buNone/>
              <a:defRPr sz="1007"/>
            </a:lvl4pPr>
            <a:lvl5pPr marL="1842516" indent="0">
              <a:buNone/>
              <a:defRPr sz="1007"/>
            </a:lvl5pPr>
            <a:lvl6pPr marL="2303145" indent="0">
              <a:buNone/>
              <a:defRPr sz="1007"/>
            </a:lvl6pPr>
            <a:lvl7pPr marL="2763774" indent="0">
              <a:buNone/>
              <a:defRPr sz="1007"/>
            </a:lvl7pPr>
            <a:lvl8pPr marL="3224403" indent="0">
              <a:buNone/>
              <a:defRPr sz="1007"/>
            </a:lvl8pPr>
            <a:lvl9pPr marL="3685032" indent="0">
              <a:buNone/>
              <a:defRPr sz="10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645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4543" y="796396"/>
            <a:ext cx="2971195" cy="2787386"/>
          </a:xfrm>
        </p:spPr>
        <p:txBody>
          <a:bodyPr anchor="b"/>
          <a:lstStyle>
            <a:lvl1pPr>
              <a:defRPr sz="32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16412" y="1719996"/>
            <a:ext cx="4663708" cy="8489359"/>
          </a:xfrm>
        </p:spPr>
        <p:txBody>
          <a:bodyPr anchor="t"/>
          <a:lstStyle>
            <a:lvl1pPr marL="0" indent="0">
              <a:buNone/>
              <a:defRPr sz="3224"/>
            </a:lvl1pPr>
            <a:lvl2pPr marL="460629" indent="0">
              <a:buNone/>
              <a:defRPr sz="2821"/>
            </a:lvl2pPr>
            <a:lvl3pPr marL="921258" indent="0">
              <a:buNone/>
              <a:defRPr sz="2418"/>
            </a:lvl3pPr>
            <a:lvl4pPr marL="1381887" indent="0">
              <a:buNone/>
              <a:defRPr sz="2015"/>
            </a:lvl4pPr>
            <a:lvl5pPr marL="1842516" indent="0">
              <a:buNone/>
              <a:defRPr sz="2015"/>
            </a:lvl5pPr>
            <a:lvl6pPr marL="2303145" indent="0">
              <a:buNone/>
              <a:defRPr sz="2015"/>
            </a:lvl6pPr>
            <a:lvl7pPr marL="2763774" indent="0">
              <a:buNone/>
              <a:defRPr sz="2015"/>
            </a:lvl7pPr>
            <a:lvl8pPr marL="3224403" indent="0">
              <a:buNone/>
              <a:defRPr sz="2015"/>
            </a:lvl8pPr>
            <a:lvl9pPr marL="3685032" indent="0">
              <a:buNone/>
              <a:defRPr sz="201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4543" y="3583782"/>
            <a:ext cx="2971195" cy="6639398"/>
          </a:xfrm>
        </p:spPr>
        <p:txBody>
          <a:bodyPr/>
          <a:lstStyle>
            <a:lvl1pPr marL="0" indent="0">
              <a:buNone/>
              <a:defRPr sz="1612"/>
            </a:lvl1pPr>
            <a:lvl2pPr marL="460629" indent="0">
              <a:buNone/>
              <a:defRPr sz="1411"/>
            </a:lvl2pPr>
            <a:lvl3pPr marL="921258" indent="0">
              <a:buNone/>
              <a:defRPr sz="1209"/>
            </a:lvl3pPr>
            <a:lvl4pPr marL="1381887" indent="0">
              <a:buNone/>
              <a:defRPr sz="1007"/>
            </a:lvl4pPr>
            <a:lvl5pPr marL="1842516" indent="0">
              <a:buNone/>
              <a:defRPr sz="1007"/>
            </a:lvl5pPr>
            <a:lvl6pPr marL="2303145" indent="0">
              <a:buNone/>
              <a:defRPr sz="1007"/>
            </a:lvl6pPr>
            <a:lvl7pPr marL="2763774" indent="0">
              <a:buNone/>
              <a:defRPr sz="1007"/>
            </a:lvl7pPr>
            <a:lvl8pPr marL="3224403" indent="0">
              <a:buNone/>
              <a:defRPr sz="1007"/>
            </a:lvl8pPr>
            <a:lvl9pPr marL="3685032" indent="0">
              <a:buNone/>
              <a:defRPr sz="10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070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3343" y="636013"/>
            <a:ext cx="7945577" cy="23089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343" y="3180053"/>
            <a:ext cx="7945577" cy="75795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33343" y="11072117"/>
            <a:ext cx="2072759" cy="636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6F97-71FE-E04F-9040-81A1A1099E0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51562" y="11072117"/>
            <a:ext cx="3109139" cy="636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06161" y="11072117"/>
            <a:ext cx="2072759" cy="636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FEAB-0837-0B4E-B33B-3C69859A0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950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21258" rtl="0" eaLnBrk="1" latinLnBrk="0" hangingPunct="1">
        <a:lnSpc>
          <a:spcPct val="90000"/>
        </a:lnSpc>
        <a:spcBef>
          <a:spcPct val="0"/>
        </a:spcBef>
        <a:buNone/>
        <a:defRPr sz="44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0315" indent="-230315" algn="l" defTabSz="921258" rtl="0" eaLnBrk="1" latinLnBrk="0" hangingPunct="1">
        <a:lnSpc>
          <a:spcPct val="90000"/>
        </a:lnSpc>
        <a:spcBef>
          <a:spcPts val="1007"/>
        </a:spcBef>
        <a:buFont typeface="Arial" panose="020B0604020202020204" pitchFamily="34" charset="0"/>
        <a:buChar char="•"/>
        <a:defRPr sz="2821" kern="1200">
          <a:solidFill>
            <a:schemeClr val="tx1"/>
          </a:solidFill>
          <a:latin typeface="+mn-lt"/>
          <a:ea typeface="+mn-ea"/>
          <a:cs typeface="+mn-cs"/>
        </a:defRPr>
      </a:lvl1pPr>
      <a:lvl2pPr marL="690944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2418" kern="1200">
          <a:solidFill>
            <a:schemeClr val="tx1"/>
          </a:solidFill>
          <a:latin typeface="+mn-lt"/>
          <a:ea typeface="+mn-ea"/>
          <a:cs typeface="+mn-cs"/>
        </a:defRPr>
      </a:lvl2pPr>
      <a:lvl3pPr marL="1151573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2015" kern="1200">
          <a:solidFill>
            <a:schemeClr val="tx1"/>
          </a:solidFill>
          <a:latin typeface="+mn-lt"/>
          <a:ea typeface="+mn-ea"/>
          <a:cs typeface="+mn-cs"/>
        </a:defRPr>
      </a:lvl3pPr>
      <a:lvl4pPr marL="1612202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4pPr>
      <a:lvl5pPr marL="2072831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5pPr>
      <a:lvl6pPr marL="2533460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6pPr>
      <a:lvl7pPr marL="2994089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7pPr>
      <a:lvl8pPr marL="3454718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8pPr>
      <a:lvl9pPr marL="3915347" indent="-230315" algn="l" defTabSz="921258" rtl="0" eaLnBrk="1" latinLnBrk="0" hangingPunct="1">
        <a:lnSpc>
          <a:spcPct val="90000"/>
        </a:lnSpc>
        <a:spcBef>
          <a:spcPts val="504"/>
        </a:spcBef>
        <a:buFont typeface="Arial" panose="020B0604020202020204" pitchFamily="34" charset="0"/>
        <a:buChar char="•"/>
        <a:defRPr sz="18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1pPr>
      <a:lvl2pPr marL="460629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2pPr>
      <a:lvl3pPr marL="921258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3pPr>
      <a:lvl4pPr marL="1381887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4pPr>
      <a:lvl5pPr marL="1842516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5pPr>
      <a:lvl6pPr marL="2303145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6pPr>
      <a:lvl7pPr marL="2763774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7pPr>
      <a:lvl8pPr marL="3224403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8pPr>
      <a:lvl9pPr marL="3685032" algn="l" defTabSz="921258" rtl="0" eaLnBrk="1" latinLnBrk="0" hangingPunct="1">
        <a:defRPr sz="18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5A0E0538-B97C-0B3D-2ADF-BF6BA775C6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5644200"/>
              </p:ext>
            </p:extLst>
          </p:nvPr>
        </p:nvGraphicFramePr>
        <p:xfrm>
          <a:off x="89707" y="653529"/>
          <a:ext cx="9032848" cy="389029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8864">
                  <a:extLst>
                    <a:ext uri="{9D8B030D-6E8A-4147-A177-3AD203B41FA5}">
                      <a16:colId xmlns:a16="http://schemas.microsoft.com/office/drawing/2014/main" val="4276873836"/>
                    </a:ext>
                  </a:extLst>
                </a:gridCol>
                <a:gridCol w="1233715">
                  <a:extLst>
                    <a:ext uri="{9D8B030D-6E8A-4147-A177-3AD203B41FA5}">
                      <a16:colId xmlns:a16="http://schemas.microsoft.com/office/drawing/2014/main" val="172803998"/>
                    </a:ext>
                  </a:extLst>
                </a:gridCol>
                <a:gridCol w="725714">
                  <a:extLst>
                    <a:ext uri="{9D8B030D-6E8A-4147-A177-3AD203B41FA5}">
                      <a16:colId xmlns:a16="http://schemas.microsoft.com/office/drawing/2014/main" val="3576096659"/>
                    </a:ext>
                  </a:extLst>
                </a:gridCol>
                <a:gridCol w="1233714">
                  <a:extLst>
                    <a:ext uri="{9D8B030D-6E8A-4147-A177-3AD203B41FA5}">
                      <a16:colId xmlns:a16="http://schemas.microsoft.com/office/drawing/2014/main" val="2015624425"/>
                    </a:ext>
                  </a:extLst>
                </a:gridCol>
                <a:gridCol w="1349829">
                  <a:extLst>
                    <a:ext uri="{9D8B030D-6E8A-4147-A177-3AD203B41FA5}">
                      <a16:colId xmlns:a16="http://schemas.microsoft.com/office/drawing/2014/main" val="4141205803"/>
                    </a:ext>
                  </a:extLst>
                </a:gridCol>
                <a:gridCol w="1277257">
                  <a:extLst>
                    <a:ext uri="{9D8B030D-6E8A-4147-A177-3AD203B41FA5}">
                      <a16:colId xmlns:a16="http://schemas.microsoft.com/office/drawing/2014/main" val="139549402"/>
                    </a:ext>
                  </a:extLst>
                </a:gridCol>
                <a:gridCol w="1132114">
                  <a:extLst>
                    <a:ext uri="{9D8B030D-6E8A-4147-A177-3AD203B41FA5}">
                      <a16:colId xmlns:a16="http://schemas.microsoft.com/office/drawing/2014/main" val="128897964"/>
                    </a:ext>
                  </a:extLst>
                </a:gridCol>
                <a:gridCol w="1081641">
                  <a:extLst>
                    <a:ext uri="{9D8B030D-6E8A-4147-A177-3AD203B41FA5}">
                      <a16:colId xmlns:a16="http://schemas.microsoft.com/office/drawing/2014/main" val="1592378688"/>
                    </a:ext>
                  </a:extLst>
                </a:gridCol>
              </a:tblGrid>
              <a:tr h="613785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lymphoid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and NK cells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monocytic cells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dritic cells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stimulatory system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thelial 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cellular matrix</a:t>
                      </a:r>
                    </a:p>
                  </a:txBody>
                  <a:tcPr marL="69092" marR="69092" marT="34546" marB="34546"/>
                </a:tc>
                <a:extLst>
                  <a:ext uri="{0D108BD9-81ED-4DB2-BD59-A6C34878D82A}">
                    <a16:rowId xmlns:a16="http://schemas.microsoft.com/office/drawing/2014/main" val="2404143153"/>
                  </a:ext>
                </a:extLst>
              </a:tr>
              <a:tr h="1387802">
                <a:tc>
                  <a:txBody>
                    <a:bodyPr/>
                    <a:lstStyle/>
                    <a:p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I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RA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DR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7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</a:t>
                      </a:r>
                    </a:p>
                    <a:p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5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2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6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0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c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5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O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t cell tryptase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 DC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9A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c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licular DC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1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3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5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OS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1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L-1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34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1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4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mentin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</a:p>
                    <a:p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SMA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extLst>
                  <a:ext uri="{0D108BD9-81ED-4DB2-BD59-A6C34878D82A}">
                    <a16:rowId xmlns:a16="http://schemas.microsoft.com/office/drawing/2014/main" val="3527917322"/>
                  </a:ext>
                </a:extLst>
              </a:tr>
              <a:tr h="7208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ion,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toxic T cells, </a:t>
                      </a:r>
                      <a:r>
                        <a:rPr lang="en-US" sz="11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h</a:t>
                      </a: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Tregs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cells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yte-Macrophage 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cytoid DC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atics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9070835"/>
                  </a:ext>
                </a:extLst>
              </a:tr>
              <a:tr h="1126649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9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0 </a:t>
                      </a:r>
                    </a:p>
                    <a:p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-67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zyme B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1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38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8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4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8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3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2Gal3</a:t>
                      </a:r>
                    </a:p>
                    <a:p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cin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23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F4</a:t>
                      </a:r>
                    </a:p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8</a:t>
                      </a: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oplanin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092" marR="69092" marT="34546" marB="34546"/>
                </a:tc>
                <a:extLst>
                  <a:ext uri="{0D108BD9-81ED-4DB2-BD59-A6C34878D82A}">
                    <a16:rowId xmlns:a16="http://schemas.microsoft.com/office/drawing/2014/main" val="409181073"/>
                  </a:ext>
                </a:extLst>
              </a:tr>
            </a:tbl>
          </a:graphicData>
        </a:graphic>
      </p:graphicFrame>
      <p:sp>
        <p:nvSpPr>
          <p:cNvPr id="3" name="Titel 1">
            <a:extLst>
              <a:ext uri="{FF2B5EF4-FFF2-40B4-BE49-F238E27FC236}">
                <a16:creationId xmlns:a16="http://schemas.microsoft.com/office/drawing/2014/main" id="{B56F3304-978E-5522-7DC1-6FC12D404A0F}"/>
              </a:ext>
            </a:extLst>
          </p:cNvPr>
          <p:cNvSpPr txBox="1">
            <a:spLocks/>
          </p:cNvSpPr>
          <p:nvPr/>
        </p:nvSpPr>
        <p:spPr>
          <a:xfrm>
            <a:off x="-1" y="0"/>
            <a:ext cx="3318933" cy="6746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10963181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A373E4-5D35-345A-9463-8770D8430940}"/>
              </a:ext>
            </a:extLst>
          </p:cNvPr>
          <p:cNvSpPr txBox="1">
            <a:spLocks/>
          </p:cNvSpPr>
          <p:nvPr/>
        </p:nvSpPr>
        <p:spPr>
          <a:xfrm>
            <a:off x="0" y="27253"/>
            <a:ext cx="2612571" cy="3430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lemental Table 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D2F940-BA47-E16C-605F-6FB23AC56B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211" y="370307"/>
            <a:ext cx="7051796" cy="11452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0442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el 1">
            <a:extLst>
              <a:ext uri="{FF2B5EF4-FFF2-40B4-BE49-F238E27FC236}">
                <a16:creationId xmlns:a16="http://schemas.microsoft.com/office/drawing/2014/main" id="{8772E1C7-D085-72AF-6DCB-7398B7303D99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2843868" cy="6485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lemental Table 3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ED9FF6-3D87-3CAE-4C9C-EEDC2169AC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2073512"/>
              </p:ext>
            </p:extLst>
          </p:nvPr>
        </p:nvGraphicFramePr>
        <p:xfrm>
          <a:off x="451765" y="1616789"/>
          <a:ext cx="7076392" cy="22018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1254">
                  <a:extLst>
                    <a:ext uri="{9D8B030D-6E8A-4147-A177-3AD203B41FA5}">
                      <a16:colId xmlns:a16="http://schemas.microsoft.com/office/drawing/2014/main" val="3571616280"/>
                    </a:ext>
                  </a:extLst>
                </a:gridCol>
                <a:gridCol w="734487">
                  <a:extLst>
                    <a:ext uri="{9D8B030D-6E8A-4147-A177-3AD203B41FA5}">
                      <a16:colId xmlns:a16="http://schemas.microsoft.com/office/drawing/2014/main" val="3972856358"/>
                    </a:ext>
                  </a:extLst>
                </a:gridCol>
                <a:gridCol w="793624">
                  <a:extLst>
                    <a:ext uri="{9D8B030D-6E8A-4147-A177-3AD203B41FA5}">
                      <a16:colId xmlns:a16="http://schemas.microsoft.com/office/drawing/2014/main" val="3818999678"/>
                    </a:ext>
                  </a:extLst>
                </a:gridCol>
                <a:gridCol w="2579278">
                  <a:extLst>
                    <a:ext uri="{9D8B030D-6E8A-4147-A177-3AD203B41FA5}">
                      <a16:colId xmlns:a16="http://schemas.microsoft.com/office/drawing/2014/main" val="454256904"/>
                    </a:ext>
                  </a:extLst>
                </a:gridCol>
                <a:gridCol w="2157749">
                  <a:extLst>
                    <a:ext uri="{9D8B030D-6E8A-4147-A177-3AD203B41FA5}">
                      <a16:colId xmlns:a16="http://schemas.microsoft.com/office/drawing/2014/main" val="10581490"/>
                    </a:ext>
                  </a:extLst>
                </a:gridCol>
              </a:tblGrid>
              <a:tr h="348251"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1" u="none" strike="noStrike" dirty="0">
                          <a:effectLst/>
                        </a:rPr>
                        <a:t>Sample ID</a:t>
                      </a:r>
                    </a:p>
                    <a:p>
                      <a:pPr algn="ctr" fontAlgn="t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1" u="none" strike="noStrike" dirty="0">
                          <a:effectLst/>
                        </a:rPr>
                        <a:t>SNV, Ins/Del (Tiers 1 and 2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1" u="none" strike="noStrike" dirty="0">
                          <a:effectLst/>
                        </a:rPr>
                        <a:t>CNV</a:t>
                      </a:r>
                    </a:p>
                    <a:p>
                      <a:pPr algn="ctr" fontAlgn="t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1" u="none" strike="noStrike" dirty="0">
                          <a:effectLst/>
                        </a:rPr>
                        <a:t>SNV of Uncertain Significance (Tier 3)</a:t>
                      </a:r>
                    </a:p>
                    <a:p>
                      <a:pPr algn="ctr" fontAlgn="t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1" u="none" strike="noStrike" dirty="0">
                          <a:effectLst/>
                        </a:rPr>
                        <a:t>Very Low-level Mosaic SNV (&lt;0.5%)</a:t>
                      </a:r>
                    </a:p>
                    <a:p>
                      <a:pPr algn="ctr" fontAlgn="t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36255803"/>
                  </a:ext>
                </a:extLst>
              </a:tr>
              <a:tr h="265470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UCD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02609.3(</a:t>
                      </a:r>
                      <a:r>
                        <a:rPr lang="en-US" sz="700" i="1" u="none" strike="noStrike" dirty="0">
                          <a:effectLst/>
                        </a:rPr>
                        <a:t>PDGFRB</a:t>
                      </a:r>
                      <a:r>
                        <a:rPr lang="en-US" sz="700" u="none" strike="noStrike" dirty="0">
                          <a:effectLst/>
                        </a:rPr>
                        <a:t>):c.2224G&gt;A, p.Asp742Asn(48%)</a:t>
                      </a:r>
                    </a:p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03722.5(</a:t>
                      </a:r>
                      <a:r>
                        <a:rPr lang="en-US" sz="700" i="1" u="none" strike="noStrike" dirty="0">
                          <a:effectLst/>
                        </a:rPr>
                        <a:t>TP63</a:t>
                      </a:r>
                      <a:r>
                        <a:rPr lang="en-US" sz="700" u="none" strike="noStrike" dirty="0">
                          <a:effectLst/>
                        </a:rPr>
                        <a:t>):c.674T&gt;C, p.Ile225Thr(39%) NM_018313.4(</a:t>
                      </a:r>
                      <a:r>
                        <a:rPr lang="en-US" sz="700" i="1" u="none" strike="noStrike" dirty="0">
                          <a:effectLst/>
                        </a:rPr>
                        <a:t>PBRM1</a:t>
                      </a:r>
                      <a:r>
                        <a:rPr lang="en-US" sz="700" u="none" strike="noStrike" dirty="0">
                          <a:effectLst/>
                        </a:rPr>
                        <a:t>):c.3520C&gt;G, p.Pro1174Ala(48%)                    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u="none" strike="noStrike" dirty="0">
                          <a:effectLst/>
                        </a:rPr>
                        <a:t>NM_004304.5(</a:t>
                      </a:r>
                      <a:r>
                        <a:rPr lang="en-US" sz="700" i="1" u="none" strike="noStrike" dirty="0">
                          <a:effectLst/>
                        </a:rPr>
                        <a:t>ALK</a:t>
                      </a:r>
                      <a:r>
                        <a:rPr lang="en-US" sz="700" u="none" strike="noStrike" dirty="0">
                          <a:effectLst/>
                        </a:rPr>
                        <a:t>):c.875G&gt;A, p.Arg292His(0.39%)</a:t>
                      </a: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1506439572"/>
                  </a:ext>
                </a:extLst>
              </a:tr>
              <a:tr h="223603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UCD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>
                          <a:effectLst/>
                        </a:rPr>
                        <a:t>Non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2609.4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RB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1997A&gt;G, p.Asn666Ser(0.4%) </a:t>
                      </a:r>
                    </a:p>
                    <a:p>
                      <a:pPr algn="l" fontAlgn="t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304.5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K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875G&gt;A, p.Arg292His(0.49%)       NM_001123385.2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O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3866G&gt;A, p.Gly1289Asp(0.31%)</a:t>
                      </a: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3877624696"/>
                  </a:ext>
                </a:extLst>
              </a:tr>
              <a:tr h="320455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UCD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>
                          <a:effectLst/>
                        </a:rPr>
                        <a:t>Non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04656.4(</a:t>
                      </a:r>
                      <a:r>
                        <a:rPr lang="en-US" sz="700" i="1" u="none" strike="noStrike" dirty="0">
                          <a:effectLst/>
                        </a:rPr>
                        <a:t>BAP1</a:t>
                      </a:r>
                      <a:r>
                        <a:rPr lang="en-US" sz="700" u="none" strike="noStrike" dirty="0">
                          <a:effectLst/>
                        </a:rPr>
                        <a:t>):c.722A&gt;G, p.Tyr241Cys(46%)</a:t>
                      </a:r>
                      <a:br>
                        <a:rPr lang="en-US" sz="700" u="none" strike="noStrike" dirty="0">
                          <a:effectLst/>
                        </a:rPr>
                      </a:br>
                      <a:r>
                        <a:rPr lang="en-US" sz="700" u="none" strike="noStrike" dirty="0">
                          <a:effectLst/>
                        </a:rPr>
                        <a:t>NM_007294.4(</a:t>
                      </a:r>
                      <a:r>
                        <a:rPr lang="en-US" sz="700" i="1" u="none" strike="noStrike" dirty="0">
                          <a:effectLst/>
                        </a:rPr>
                        <a:t>BRCA1</a:t>
                      </a:r>
                      <a:r>
                        <a:rPr lang="en-US" sz="700" u="none" strike="noStrike" dirty="0">
                          <a:effectLst/>
                        </a:rPr>
                        <a:t>):c.3403C&gt;G, p.Gln1135Glu(45%)</a:t>
                      </a:r>
                      <a:br>
                        <a:rPr lang="en-US" sz="700" u="none" strike="noStrike" dirty="0">
                          <a:effectLst/>
                        </a:rPr>
                      </a:br>
                      <a:r>
                        <a:rPr lang="en-US" sz="700" u="none" strike="noStrike" dirty="0">
                          <a:effectLst/>
                        </a:rPr>
                        <a:t>NM_002944.3(</a:t>
                      </a:r>
                      <a:r>
                        <a:rPr lang="en-US" sz="700" i="1" u="none" strike="noStrike" dirty="0">
                          <a:effectLst/>
                        </a:rPr>
                        <a:t>ROS1</a:t>
                      </a:r>
                      <a:r>
                        <a:rPr lang="en-US" sz="700" u="none" strike="noStrike" dirty="0">
                          <a:effectLst/>
                        </a:rPr>
                        <a:t>):c.5842C&gt;, p.Arg1948Cys(44%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123385.2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O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3866G&gt;A, p.Gly1289Asp(0.69%)</a:t>
                      </a: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3785593835"/>
                  </a:ext>
                </a:extLst>
              </a:tr>
              <a:tr h="439641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CD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32043.3(</a:t>
                      </a:r>
                      <a:r>
                        <a:rPr lang="en-US" sz="700" i="1" u="none" strike="noStrike" dirty="0">
                          <a:effectLst/>
                        </a:rPr>
                        <a:t>BRIP1</a:t>
                      </a:r>
                      <a:r>
                        <a:rPr lang="en-US" sz="700" u="none" strike="noStrike" dirty="0">
                          <a:effectLst/>
                        </a:rPr>
                        <a:t>):c.2564G&gt;A, p.Arg855His(48%), NM_006290.3(</a:t>
                      </a:r>
                      <a:r>
                        <a:rPr lang="en-US" sz="700" i="1" u="none" strike="noStrike" dirty="0">
                          <a:effectLst/>
                        </a:rPr>
                        <a:t>TNFAIP3</a:t>
                      </a:r>
                      <a:r>
                        <a:rPr lang="en-US" sz="700" u="none" strike="noStrike" dirty="0">
                          <a:effectLst/>
                        </a:rPr>
                        <a:t>):c.539_540delinsGA, p.Pro180Arg(37%) NM_030662.3(</a:t>
                      </a:r>
                      <a:r>
                        <a:rPr lang="en-US" sz="700" i="1" u="none" strike="noStrike" dirty="0">
                          <a:effectLst/>
                        </a:rPr>
                        <a:t>MAP2K2</a:t>
                      </a:r>
                      <a:r>
                        <a:rPr lang="en-US" sz="700" u="none" strike="noStrike" dirty="0">
                          <a:effectLst/>
                        </a:rPr>
                        <a:t>):c.1039A&gt;G, p.Asn347Asp(48%) NM_005417.4(</a:t>
                      </a:r>
                      <a:r>
                        <a:rPr lang="en-US" sz="700" i="1" u="none" strike="noStrike" dirty="0">
                          <a:effectLst/>
                        </a:rPr>
                        <a:t>SRC</a:t>
                      </a:r>
                      <a:r>
                        <a:rPr lang="en-US" sz="700" u="none" strike="noStrike" dirty="0">
                          <a:effectLst/>
                        </a:rPr>
                        <a:t>):c.-1C&gt;G, p.?(46%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304.5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K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875G&gt;A, p.Arg292His(0.23%)</a:t>
                      </a: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2221178636"/>
                  </a:ext>
                </a:extLst>
              </a:tr>
              <a:tr h="1763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CD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05120.3(</a:t>
                      </a:r>
                      <a:r>
                        <a:rPr lang="en-US" sz="700" i="1" u="none" strike="noStrike" dirty="0">
                          <a:effectLst/>
                        </a:rPr>
                        <a:t>MED12</a:t>
                      </a:r>
                      <a:r>
                        <a:rPr lang="en-US" sz="700" u="none" strike="noStrike" dirty="0">
                          <a:effectLst/>
                        </a:rPr>
                        <a:t>):c.4037G&gt;A, p.Arg1346His(0.3%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940105595"/>
                  </a:ext>
                </a:extLst>
              </a:tr>
              <a:tr h="154314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CD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304.5(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K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:c.875G&gt;A, p.Arg292His(0.26%)</a:t>
                      </a: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3033448317"/>
                  </a:ext>
                </a:extLst>
              </a:tr>
              <a:tr h="113466"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CD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M_000142.4(</a:t>
                      </a:r>
                      <a:r>
                        <a:rPr lang="en-US" sz="700" i="1" u="none" strike="noStrike" dirty="0">
                          <a:effectLst/>
                        </a:rPr>
                        <a:t>FGFR3</a:t>
                      </a:r>
                      <a:r>
                        <a:rPr lang="en-US" sz="700" u="none" strike="noStrike" dirty="0">
                          <a:effectLst/>
                        </a:rPr>
                        <a:t>):c.2126A&gt;G, p.Glu709Gly(46%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u="none" strike="noStrike" dirty="0">
                          <a:effectLst/>
                        </a:rPr>
                        <a:t>Non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5" marR="3225" marT="3225" marB="0" anchor="b"/>
                </a:tc>
                <a:extLst>
                  <a:ext uri="{0D108BD9-81ED-4DB2-BD59-A6C34878D82A}">
                    <a16:rowId xmlns:a16="http://schemas.microsoft.com/office/drawing/2014/main" val="18691969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96212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240</TotalTime>
  <Words>588</Words>
  <Application>Microsoft Office PowerPoint</Application>
  <PresentationFormat>Custom</PresentationFormat>
  <Paragraphs>12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llai, Vinodh</dc:creator>
  <cp:lastModifiedBy>Pillai, Vinodh</cp:lastModifiedBy>
  <cp:revision>123</cp:revision>
  <dcterms:created xsi:type="dcterms:W3CDTF">2023-09-09T12:55:58Z</dcterms:created>
  <dcterms:modified xsi:type="dcterms:W3CDTF">2024-06-14T20:58:05Z</dcterms:modified>
</cp:coreProperties>
</file>